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119813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80" d="100"/>
          <a:sy n="80" d="100"/>
        </p:scale>
        <p:origin x="1670" y="-1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62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760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488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06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1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561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7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163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163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05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82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52E118-174B-4384-B15F-433CFA3BF618}" type="datetimeFigureOut">
              <a:rPr lang="en-US" smtClean="0"/>
              <a:t>4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18F1BF-1494-4292-A6ED-1457D0FF36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940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3F2706-AFD9-48AE-B25C-6AA2BDE34C45}"/>
              </a:ext>
            </a:extLst>
          </p:cNvPr>
          <p:cNvSpPr txBox="1"/>
          <p:nvPr/>
        </p:nvSpPr>
        <p:spPr>
          <a:xfrm>
            <a:off x="250741" y="6099481"/>
            <a:ext cx="561832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CP directly regulated the protein expressed level of HMGB1 instead of transcriptional express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transcriptional expression of HMGB1 in Huh7 cells treated with VCP-siRNA and MHCC-LM3 cells transfected by ectopic VCP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 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tein expression of HMGB1 was decreased in Huh7 cells when VCP expression was inhibited via siRNA or small molecule NMS873 (10 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Μ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2 h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,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protein expression of HMGB1 was upregulated in MHCC-LM3 cells with ectopic overexpres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CP. All * P＜0.05, ** P ＜0.01, **** P ＜0.0001, and ns: no significance.</a:t>
            </a:r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A2341A6D-DA51-4E34-B9B6-14F11E282A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294" y="689162"/>
            <a:ext cx="5956811" cy="5360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1150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</TotalTime>
  <Words>11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雅 意天空</dc:creator>
  <cp:lastModifiedBy>雅 意天空</cp:lastModifiedBy>
  <cp:revision>10</cp:revision>
  <dcterms:created xsi:type="dcterms:W3CDTF">2022-04-15T05:49:56Z</dcterms:created>
  <dcterms:modified xsi:type="dcterms:W3CDTF">2022-04-21T06:47:58Z</dcterms:modified>
</cp:coreProperties>
</file>